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6032C-84BE-3E44-A88D-557C86F51C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23A93A7-D854-3A46-A20A-1A7CF60120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D7E31B-2874-D347-B126-FABA741DF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446DA7-728D-0749-81B6-152419AC0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0C963B-76E9-4A48-B8DA-7ABA8FE19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353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76963-757D-7B48-891D-D14CA80670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948C9A-8A15-464C-B14E-E2B1ED6D35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205ED5-4216-5348-AFBB-1B0C24C06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E9D4AA-A04A-F442-A707-607B85739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A56EF1-9F5F-1F4F-98AC-78BE267B4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258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26CF56-2E0D-E74C-9EA6-CAD492CDAF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488B6F-0EC7-F64D-B2D3-903D828D5A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09014C-2F1C-BA4B-B448-AC0423D71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96DB31-4B99-E547-9786-D5186460B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949E20-4F2A-F54F-8859-57F8682F7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923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D42E99-44BD-9B43-8F9A-A27B51064D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83289A-651B-7643-A1BF-AC901138CA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3FF760-67E7-4B43-8D2B-6F3BD1749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B6A777-7B41-7946-AACB-271943661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C3FA37-D52B-344D-9819-2F282885A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471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8B010B-9E57-2E4C-B71B-FC11520058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8697F2-3FB5-D24C-84C7-C75D032453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0FF07B-79EC-C845-B5D8-D9AC71AB5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F7AE72-F5EF-1A4A-9CCB-A33B3EAF0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083E24-2E8C-DF42-ACF5-ABB082B02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189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378D4D-2661-674B-B93F-0F4E21DA27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9F72B2-601D-5348-8FB1-4FEB115DEE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7F9C71-4829-5A4D-82E2-D5111DB635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C9D266-433A-4C4B-A408-38FBF52C3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19C918-E660-D440-95DE-C0F08EB6D0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9D1BE-7229-5F43-A55B-C79CFE19E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799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4FACD-98D8-1E42-94A3-4939FE2F4A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BA0094-0F6E-7D44-83DF-83034A8954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885C56-0A98-5A47-8633-AD8C66BE18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8547A12-F52F-3845-8A74-4A1B3FBB4F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EF1968-D79C-0C40-A8F0-5CBE667D00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3BFAE4-4C91-1E48-AC09-D029EEF2D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724A08E-0732-7F47-802F-C2273A43E3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E29AF8A-92EE-0648-8A91-6CB4507DF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878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6F2AEE-E0E8-6A47-8C94-CA69A023E9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AC48828-6FAF-F745-92AD-8B5EAEA8A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7BA9F6-5201-3441-B4A6-6DAC0EB66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215AA8D-7192-374D-8FCB-5FF3731DA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576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9DC8361-BBE9-4947-B6BE-8E250C303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79FAF56-1D48-1C44-B9D3-C0F4B7DD2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DA0433-8869-A247-8DFB-F9B8A0CC3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720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891DF-F5AB-594B-80B7-5C6C581A1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862564-4842-A040-8E74-5B57EC917A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B41E06-D53F-344E-AF16-F2146E145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DDC552-8050-0740-AB05-8FC31F529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12EB2F-60BB-8743-BCED-AACEB461E9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9B99C7-49B4-B64D-8F19-0C992E603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403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CD7CFD-100E-DC48-8F27-8E52800663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D4A7AC1-5021-334C-A21E-C7FAFDD9BE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86F6B5-80C1-CA4F-9482-C689D5DE12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7F6186-3B0F-D646-9276-E084408029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FFCFB3-BA38-CB4C-9667-8FB371C5B6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79E2AC-1C22-5C48-B5E1-8D454F799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034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BEEAB6-4B74-A847-B279-B8761FA970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A6FE80-FC97-6C47-AD56-C6BDF05E4D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EE6F0F-85B3-4246-9BF3-A4AD99BFC2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21965-ABA0-6E40-AE21-4742A2ADF135}" type="datetimeFigureOut">
              <a:rPr lang="en-US" smtClean="0"/>
              <a:t>9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66FB51-89ED-C047-8939-46172511A5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90ED31-D30C-454C-AB22-7DCA6F4920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F1E40E-C10B-6544-9062-BFA1F92DA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311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F6DEE29-F5BB-F647-B9C5-0485E05C24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3491" y="1361871"/>
            <a:ext cx="10169527" cy="500001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C282ED7-C7D5-084A-A9A0-553206430CCD}"/>
              </a:ext>
            </a:extLst>
          </p:cNvPr>
          <p:cNvSpPr txBox="1"/>
          <p:nvPr/>
        </p:nvSpPr>
        <p:spPr>
          <a:xfrm>
            <a:off x="3059266" y="158178"/>
            <a:ext cx="914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Symbol" pitchFamily="2" charset="2"/>
              </a:rPr>
              <a:t>d</a:t>
            </a:r>
            <a:r>
              <a:rPr lang="en-US" dirty="0"/>
              <a:t>T3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1F91AD2-4E38-8D40-841D-3A9014FDB2A4}"/>
              </a:ext>
            </a:extLst>
          </p:cNvPr>
          <p:cNvSpPr txBox="1"/>
          <p:nvPr/>
        </p:nvSpPr>
        <p:spPr>
          <a:xfrm>
            <a:off x="2980438" y="1060578"/>
            <a:ext cx="568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K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37FF711-C2ED-9B45-A018-0018E7A4984D}"/>
              </a:ext>
            </a:extLst>
          </p:cNvPr>
          <p:cNvSpPr txBox="1"/>
          <p:nvPr/>
        </p:nvSpPr>
        <p:spPr>
          <a:xfrm>
            <a:off x="2387954" y="1060579"/>
            <a:ext cx="4757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U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32F888-F501-AB4C-8308-92C27961A07A}"/>
              </a:ext>
            </a:extLst>
          </p:cNvPr>
          <p:cNvSpPr txBox="1"/>
          <p:nvPr/>
        </p:nvSpPr>
        <p:spPr>
          <a:xfrm>
            <a:off x="1813348" y="1060579"/>
            <a:ext cx="4757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UV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1FDE0B5-E249-A849-8EB1-D13D6EBE53CD}"/>
              </a:ext>
            </a:extLst>
          </p:cNvPr>
          <p:cNvSpPr txBox="1"/>
          <p:nvPr/>
        </p:nvSpPr>
        <p:spPr>
          <a:xfrm>
            <a:off x="3517657" y="1060578"/>
            <a:ext cx="568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K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BC6DF0-8AE9-0E4E-8432-B44B2F9611C1}"/>
              </a:ext>
            </a:extLst>
          </p:cNvPr>
          <p:cNvSpPr txBox="1"/>
          <p:nvPr/>
        </p:nvSpPr>
        <p:spPr>
          <a:xfrm>
            <a:off x="4006236" y="1060578"/>
            <a:ext cx="568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C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A1EEB7A-FF6B-3F45-B33F-27DA87761B0E}"/>
              </a:ext>
            </a:extLst>
          </p:cNvPr>
          <p:cNvSpPr txBox="1"/>
          <p:nvPr/>
        </p:nvSpPr>
        <p:spPr>
          <a:xfrm>
            <a:off x="4545411" y="1059086"/>
            <a:ext cx="568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2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017105-CF0D-9040-B55B-511231FF16BB}"/>
              </a:ext>
            </a:extLst>
          </p:cNvPr>
          <p:cNvSpPr txBox="1"/>
          <p:nvPr/>
        </p:nvSpPr>
        <p:spPr>
          <a:xfrm>
            <a:off x="3410653" y="684320"/>
            <a:ext cx="14263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IE</a:t>
            </a:r>
            <a:r>
              <a:rPr lang="en-US" sz="1400" baseline="30000" dirty="0" err="1"/>
              <a:t>k</a:t>
            </a:r>
            <a:r>
              <a:rPr lang="en-US" sz="1400" dirty="0"/>
              <a:t> tetrame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074A656-3123-0E4A-B70C-B3DCD2B34913}"/>
              </a:ext>
            </a:extLst>
          </p:cNvPr>
          <p:cNvSpPr txBox="1"/>
          <p:nvPr/>
        </p:nvSpPr>
        <p:spPr>
          <a:xfrm>
            <a:off x="8001549" y="158178"/>
            <a:ext cx="914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Symbol" pitchFamily="2" charset="2"/>
              </a:rPr>
              <a:t>a</a:t>
            </a:r>
            <a:r>
              <a:rPr lang="en-US" dirty="0"/>
              <a:t>S138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06C3A1B-B538-DA48-8495-3EA721D23049}"/>
              </a:ext>
            </a:extLst>
          </p:cNvPr>
          <p:cNvSpPr txBox="1"/>
          <p:nvPr/>
        </p:nvSpPr>
        <p:spPr>
          <a:xfrm>
            <a:off x="8001549" y="1019773"/>
            <a:ext cx="568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K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A29B4E9-C32A-2448-8EEE-E1C1F9BECE1C}"/>
              </a:ext>
            </a:extLst>
          </p:cNvPr>
          <p:cNvSpPr txBox="1"/>
          <p:nvPr/>
        </p:nvSpPr>
        <p:spPr>
          <a:xfrm>
            <a:off x="7302063" y="1019774"/>
            <a:ext cx="4757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U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DCE5DF4-C871-864C-AEED-80B9E51CFCC3}"/>
              </a:ext>
            </a:extLst>
          </p:cNvPr>
          <p:cNvSpPr txBox="1"/>
          <p:nvPr/>
        </p:nvSpPr>
        <p:spPr>
          <a:xfrm>
            <a:off x="6727457" y="1019774"/>
            <a:ext cx="4757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UV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65D92E2-A3ED-2548-8EDD-0C41E84E82D7}"/>
              </a:ext>
            </a:extLst>
          </p:cNvPr>
          <p:cNvSpPr txBox="1"/>
          <p:nvPr/>
        </p:nvSpPr>
        <p:spPr>
          <a:xfrm>
            <a:off x="8538768" y="1019773"/>
            <a:ext cx="568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K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991109F-179C-6441-9957-F5D67B3232C2}"/>
              </a:ext>
            </a:extLst>
          </p:cNvPr>
          <p:cNvSpPr txBox="1"/>
          <p:nvPr/>
        </p:nvSpPr>
        <p:spPr>
          <a:xfrm>
            <a:off x="9037075" y="1019773"/>
            <a:ext cx="568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C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A282727-74A2-E94E-A370-4314324D8BA5}"/>
              </a:ext>
            </a:extLst>
          </p:cNvPr>
          <p:cNvSpPr txBox="1"/>
          <p:nvPr/>
        </p:nvSpPr>
        <p:spPr>
          <a:xfrm>
            <a:off x="9576250" y="1018281"/>
            <a:ext cx="568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2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C39224B-E642-1D48-A449-0D0D08D93184}"/>
              </a:ext>
            </a:extLst>
          </p:cNvPr>
          <p:cNvSpPr txBox="1"/>
          <p:nvPr/>
        </p:nvSpPr>
        <p:spPr>
          <a:xfrm>
            <a:off x="8451220" y="643515"/>
            <a:ext cx="14263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IE</a:t>
            </a:r>
            <a:r>
              <a:rPr lang="en-US" sz="1400" baseline="30000" dirty="0" err="1"/>
              <a:t>k</a:t>
            </a:r>
            <a:r>
              <a:rPr lang="en-US" sz="1400" dirty="0"/>
              <a:t> tetrame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5EC45DC-30E6-054D-9923-3B23528B2493}"/>
              </a:ext>
            </a:extLst>
          </p:cNvPr>
          <p:cNvSpPr txBox="1"/>
          <p:nvPr/>
        </p:nvSpPr>
        <p:spPr>
          <a:xfrm>
            <a:off x="705123" y="2791329"/>
            <a:ext cx="69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7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6AE316E-00C3-B843-A042-58F6F88AA824}"/>
              </a:ext>
            </a:extLst>
          </p:cNvPr>
          <p:cNvSpPr txBox="1"/>
          <p:nvPr/>
        </p:nvSpPr>
        <p:spPr>
          <a:xfrm>
            <a:off x="662819" y="3261817"/>
            <a:ext cx="69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5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4F666D2-089F-B44D-B36D-3B32B41E2227}"/>
              </a:ext>
            </a:extLst>
          </p:cNvPr>
          <p:cNvSpPr txBox="1"/>
          <p:nvPr/>
        </p:nvSpPr>
        <p:spPr>
          <a:xfrm>
            <a:off x="664872" y="2612430"/>
            <a:ext cx="69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10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EE809A3-ED8F-2A41-A6EE-9EB1033F0A6A}"/>
              </a:ext>
            </a:extLst>
          </p:cNvPr>
          <p:cNvSpPr txBox="1"/>
          <p:nvPr/>
        </p:nvSpPr>
        <p:spPr>
          <a:xfrm>
            <a:off x="662819" y="3625510"/>
            <a:ext cx="69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37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610831B-453E-3C4E-AF8E-60B544D5B324}"/>
              </a:ext>
            </a:extLst>
          </p:cNvPr>
          <p:cNvSpPr txBox="1"/>
          <p:nvPr/>
        </p:nvSpPr>
        <p:spPr>
          <a:xfrm>
            <a:off x="662819" y="3989203"/>
            <a:ext cx="69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2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B30033E-C313-E244-9253-3F4C8C33B224}"/>
              </a:ext>
            </a:extLst>
          </p:cNvPr>
          <p:cNvSpPr txBox="1"/>
          <p:nvPr/>
        </p:nvSpPr>
        <p:spPr>
          <a:xfrm>
            <a:off x="6509300" y="2791329"/>
            <a:ext cx="69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7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B8CCCE7-C5E7-7E4E-96BB-8856FBC968C8}"/>
              </a:ext>
            </a:extLst>
          </p:cNvPr>
          <p:cNvSpPr txBox="1"/>
          <p:nvPr/>
        </p:nvSpPr>
        <p:spPr>
          <a:xfrm>
            <a:off x="6466996" y="3310457"/>
            <a:ext cx="69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5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07331A4-219F-6542-9601-D405E6671385}"/>
              </a:ext>
            </a:extLst>
          </p:cNvPr>
          <p:cNvSpPr txBox="1"/>
          <p:nvPr/>
        </p:nvSpPr>
        <p:spPr>
          <a:xfrm>
            <a:off x="6469049" y="2612430"/>
            <a:ext cx="69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10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F965134-7D56-0A4F-8493-91A520011A78}"/>
              </a:ext>
            </a:extLst>
          </p:cNvPr>
          <p:cNvSpPr txBox="1"/>
          <p:nvPr/>
        </p:nvSpPr>
        <p:spPr>
          <a:xfrm>
            <a:off x="6466996" y="3674150"/>
            <a:ext cx="69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37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B062642-DAE0-0D48-884D-96825107A09C}"/>
              </a:ext>
            </a:extLst>
          </p:cNvPr>
          <p:cNvSpPr txBox="1"/>
          <p:nvPr/>
        </p:nvSpPr>
        <p:spPr>
          <a:xfrm>
            <a:off x="6466996" y="4086480"/>
            <a:ext cx="69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2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EDF8A27-AD6C-5E47-BA1B-75A8FFB069AD}"/>
              </a:ext>
            </a:extLst>
          </p:cNvPr>
          <p:cNvSpPr txBox="1"/>
          <p:nvPr/>
        </p:nvSpPr>
        <p:spPr>
          <a:xfrm>
            <a:off x="4909227" y="2994800"/>
            <a:ext cx="13326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TCR</a:t>
            </a:r>
            <a:r>
              <a:rPr lang="en-US" sz="1400" dirty="0">
                <a:solidFill>
                  <a:srgbClr val="FF0000"/>
                </a:solidFill>
                <a:latin typeface="Symbol" pitchFamily="2" charset="2"/>
              </a:rPr>
              <a:t>a</a:t>
            </a:r>
            <a:r>
              <a:rPr lang="en-US" sz="1400" dirty="0">
                <a:solidFill>
                  <a:srgbClr val="FF0000"/>
                </a:solidFill>
              </a:rPr>
              <a:t>+CD3</a:t>
            </a:r>
            <a:r>
              <a:rPr lang="en-US" sz="1400" dirty="0">
                <a:solidFill>
                  <a:srgbClr val="FF0000"/>
                </a:solidFill>
                <a:latin typeface="Symbol" pitchFamily="2" charset="2"/>
              </a:rPr>
              <a:t>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48593DC-FC3F-3743-BC43-0E012EAA8BDA}"/>
              </a:ext>
            </a:extLst>
          </p:cNvPr>
          <p:cNvSpPr txBox="1"/>
          <p:nvPr/>
        </p:nvSpPr>
        <p:spPr>
          <a:xfrm>
            <a:off x="4936358" y="3434886"/>
            <a:ext cx="1011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solidFill>
                  <a:srgbClr val="FF0000"/>
                </a:solidFill>
              </a:rPr>
              <a:t>TCR</a:t>
            </a:r>
            <a:r>
              <a:rPr lang="en-US" sz="1400" dirty="0" err="1">
                <a:solidFill>
                  <a:srgbClr val="FF0000"/>
                </a:solidFill>
                <a:latin typeface="Symbol" pitchFamily="2" charset="2"/>
              </a:rPr>
              <a:t>a</a:t>
            </a:r>
            <a:endParaRPr lang="en-US" sz="1400" dirty="0">
              <a:solidFill>
                <a:srgbClr val="FF0000"/>
              </a:solidFill>
              <a:latin typeface="Symbol" pitchFamily="2" charset="2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61BFFFA-6856-3B4C-AF41-B604DF170837}"/>
              </a:ext>
            </a:extLst>
          </p:cNvPr>
          <p:cNvSpPr txBox="1"/>
          <p:nvPr/>
        </p:nvSpPr>
        <p:spPr>
          <a:xfrm>
            <a:off x="4936358" y="4089749"/>
            <a:ext cx="1011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CD3</a:t>
            </a:r>
            <a:r>
              <a:rPr lang="en-US" sz="1400" dirty="0">
                <a:solidFill>
                  <a:srgbClr val="FF0000"/>
                </a:solidFill>
                <a:latin typeface="Symbol" pitchFamily="2" charset="2"/>
              </a:rPr>
              <a:t>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20107F6-7FD2-6F40-BF77-6CAD7C17D30F}"/>
              </a:ext>
            </a:extLst>
          </p:cNvPr>
          <p:cNvSpPr txBox="1"/>
          <p:nvPr/>
        </p:nvSpPr>
        <p:spPr>
          <a:xfrm>
            <a:off x="9990823" y="3317733"/>
            <a:ext cx="1011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solidFill>
                  <a:srgbClr val="FF0000"/>
                </a:solidFill>
              </a:rPr>
              <a:t>TCR</a:t>
            </a:r>
            <a:r>
              <a:rPr lang="en-US" sz="1400" dirty="0" err="1">
                <a:solidFill>
                  <a:srgbClr val="FF0000"/>
                </a:solidFill>
                <a:latin typeface="Symbol" pitchFamily="2" charset="2"/>
              </a:rPr>
              <a:t>a</a:t>
            </a:r>
            <a:endParaRPr lang="en-US" sz="1400" dirty="0">
              <a:solidFill>
                <a:srgbClr val="FF0000"/>
              </a:solidFill>
              <a:latin typeface="Symbol" pitchFamily="2" charset="2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2BD7383-B20F-664E-8666-7AC3BEC11578}"/>
              </a:ext>
            </a:extLst>
          </p:cNvPr>
          <p:cNvSpPr txBox="1"/>
          <p:nvPr/>
        </p:nvSpPr>
        <p:spPr>
          <a:xfrm>
            <a:off x="9990823" y="3538816"/>
            <a:ext cx="1011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solidFill>
                  <a:srgbClr val="FF0000"/>
                </a:solidFill>
              </a:rPr>
              <a:t>TCR</a:t>
            </a:r>
            <a:r>
              <a:rPr lang="en-US" sz="1400" dirty="0" err="1">
                <a:solidFill>
                  <a:srgbClr val="FF0000"/>
                </a:solidFill>
                <a:latin typeface="Symbol" pitchFamily="2" charset="2"/>
              </a:rPr>
              <a:t>b</a:t>
            </a:r>
            <a:endParaRPr lang="en-US" sz="1400" dirty="0">
              <a:solidFill>
                <a:srgbClr val="FF0000"/>
              </a:solidFill>
              <a:latin typeface="Symbol" pitchFamily="2" charset="2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DD39719-E67E-9240-A2C0-7FFA09207112}"/>
              </a:ext>
            </a:extLst>
          </p:cNvPr>
          <p:cNvSpPr txBox="1"/>
          <p:nvPr/>
        </p:nvSpPr>
        <p:spPr>
          <a:xfrm>
            <a:off x="9981612" y="2636204"/>
            <a:ext cx="13326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solidFill>
                  <a:srgbClr val="FF0000"/>
                </a:solidFill>
              </a:rPr>
              <a:t>TCR</a:t>
            </a:r>
            <a:r>
              <a:rPr lang="en-US" sz="1400" dirty="0" err="1">
                <a:solidFill>
                  <a:srgbClr val="FF0000"/>
                </a:solidFill>
                <a:latin typeface="Symbol" pitchFamily="2" charset="2"/>
              </a:rPr>
              <a:t>a</a:t>
            </a:r>
            <a:r>
              <a:rPr lang="en-US" sz="1400" dirty="0" err="1">
                <a:solidFill>
                  <a:srgbClr val="FF0000"/>
                </a:solidFill>
              </a:rPr>
              <a:t>+TCR</a:t>
            </a:r>
            <a:r>
              <a:rPr lang="en-US" sz="1400" dirty="0" err="1">
                <a:solidFill>
                  <a:srgbClr val="FF0000"/>
                </a:solidFill>
                <a:latin typeface="Symbol" pitchFamily="2" charset="2"/>
              </a:rPr>
              <a:t>b</a:t>
            </a:r>
            <a:endParaRPr lang="en-US" sz="1400" dirty="0">
              <a:solidFill>
                <a:srgbClr val="FF0000"/>
              </a:solidFill>
              <a:latin typeface="Symbol" pitchFamily="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3697313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9</TotalTime>
  <Words>40</Words>
  <Application>Microsoft Macintosh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4</cp:revision>
  <dcterms:created xsi:type="dcterms:W3CDTF">2023-09-03T16:27:09Z</dcterms:created>
  <dcterms:modified xsi:type="dcterms:W3CDTF">2023-09-04T00:16:28Z</dcterms:modified>
</cp:coreProperties>
</file>